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9FB751D-B260-4E18-B4DD-7B679368A499}" type="slidenum">
              <a:rPr b="0" lang="it-IT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0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it-IT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Segnaposto numero diapositiva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2F6C46C-3A57-4749-AE2F-11261A5286A0}" type="slidenum">
              <a:rPr b="0" lang="it-IT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0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it-IT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Segnaposto numero diapositiva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7211AEC-538E-49C3-BC27-8AA6981D773F}" type="slidenum">
              <a:rPr b="0" lang="it-IT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6FAA01-3FEA-4AFC-9EBD-05B0B4C7066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5A1824-0CD2-4DCA-A75D-3B7A733B32B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43CC62-C05B-4869-B69A-A630FADF35F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321221-BAF5-4DBE-988C-237F092D8C9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CA341B-FFF3-4136-987C-8ED93384417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34B85C-4C44-4FAC-9CD9-8D365CDD6A7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BD2973-B7C6-4D15-A526-FADFC1B2B1D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5D491F-E057-4ECA-A2FE-7DC7A9CB757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67719D-4F30-45D7-B5E8-B22AB67DCB4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AA89D1-2AE7-4EFA-BAA8-AF8CB2AF123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F9A5A7-8B45-4040-BDF9-10A2B1FC65B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AB8C49-CA7F-466D-98C7-866FD665E4B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77212A6-E12F-45CC-AA27-D45A1A60EFD6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uppo 29"/>
          <p:cNvGrpSpPr/>
          <p:nvPr/>
        </p:nvGrpSpPr>
        <p:grpSpPr>
          <a:xfrm>
            <a:off x="15840" y="725400"/>
            <a:ext cx="8962920" cy="3620520"/>
            <a:chOff x="15840" y="725400"/>
            <a:chExt cx="8962920" cy="3620520"/>
          </a:xfrm>
        </p:grpSpPr>
        <p:pic>
          <p:nvPicPr>
            <p:cNvPr id="49" name="Picture 18" descr="I:\backup\Analisi\FAST\2010_03_16\adj_os_2_vs_3.gif"/>
            <p:cNvPicPr/>
            <p:nvPr/>
          </p:nvPicPr>
          <p:blipFill>
            <a:blip r:embed="rId1"/>
            <a:stretch/>
          </p:blipFill>
          <p:spPr>
            <a:xfrm>
              <a:off x="4788000" y="827640"/>
              <a:ext cx="4190760" cy="3143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0" name="Picture 17" descr="I:\backup\Analisi\FAST\2010_03_16\adj_os_p_vs_n.gif"/>
            <p:cNvPicPr/>
            <p:nvPr/>
          </p:nvPicPr>
          <p:blipFill>
            <a:blip r:embed="rId2"/>
            <a:stretch/>
          </p:blipFill>
          <p:spPr>
            <a:xfrm>
              <a:off x="251640" y="827640"/>
              <a:ext cx="4190760" cy="3143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1" name="CasellaDiTesto 27"/>
            <p:cNvSpPr/>
            <p:nvPr/>
          </p:nvSpPr>
          <p:spPr>
            <a:xfrm>
              <a:off x="131400" y="726840"/>
              <a:ext cx="360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CasellaDiTesto 29"/>
            <p:cNvSpPr/>
            <p:nvPr/>
          </p:nvSpPr>
          <p:spPr>
            <a:xfrm>
              <a:off x="4673520" y="725400"/>
              <a:ext cx="3585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 Box 25"/>
            <p:cNvSpPr/>
            <p:nvPr/>
          </p:nvSpPr>
          <p:spPr>
            <a:xfrm>
              <a:off x="1400040" y="952200"/>
              <a:ext cx="2952720" cy="936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                 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djusted Median, 95% C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-containing regimens (n=216)      11.3, 9.8-12.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N-containing regimens (n=217)      9.7, 8.7-10.8           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N- </a:t>
              </a:r>
              <a:r>
                <a:rPr b="0" lang="en-GB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versus</a:t>
              </a: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-containing              Adjusted HR, 95% C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                                                    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.23, 1.01-1.49;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P =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0.04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54" name="AutoShape 26"/>
            <p:cNvCxnSpPr/>
            <p:nvPr/>
          </p:nvCxnSpPr>
          <p:spPr>
            <a:xfrm>
              <a:off x="1075680" y="1174680"/>
              <a:ext cx="386280" cy="360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cxnSp>
          <p:nvCxnSpPr>
            <p:cNvPr id="55" name="AutoShape 27"/>
            <p:cNvCxnSpPr/>
            <p:nvPr/>
          </p:nvCxnSpPr>
          <p:spPr>
            <a:xfrm>
              <a:off x="1075680" y="1323720"/>
              <a:ext cx="384840" cy="3600"/>
            </a:xfrm>
            <a:prstGeom prst="straightConnector1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</p:cxnSp>
        <p:cxnSp>
          <p:nvCxnSpPr>
            <p:cNvPr id="56" name="AutoShape 26"/>
            <p:cNvCxnSpPr/>
            <p:nvPr/>
          </p:nvCxnSpPr>
          <p:spPr>
            <a:xfrm>
              <a:off x="78840" y="4106880"/>
              <a:ext cx="386280" cy="360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cxnSp>
          <p:nvCxnSpPr>
            <p:cNvPr id="57" name="AutoShape 27"/>
            <p:cNvCxnSpPr/>
            <p:nvPr/>
          </p:nvCxnSpPr>
          <p:spPr>
            <a:xfrm>
              <a:off x="78840" y="4237200"/>
              <a:ext cx="384840" cy="3600"/>
            </a:xfrm>
            <a:prstGeom prst="straightConnector1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</p:cxnSp>
        <p:sp>
          <p:nvSpPr>
            <p:cNvPr id="58" name="CasellaDiTesto 32"/>
            <p:cNvSpPr/>
            <p:nvPr/>
          </p:nvSpPr>
          <p:spPr>
            <a:xfrm>
              <a:off x="15840" y="3860640"/>
              <a:ext cx="504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t ris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CasellaDiTesto 33"/>
            <p:cNvSpPr/>
            <p:nvPr/>
          </p:nvSpPr>
          <p:spPr>
            <a:xfrm>
              <a:off x="287280" y="4008240"/>
              <a:ext cx="502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21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21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CasellaDiTesto 34"/>
            <p:cNvSpPr/>
            <p:nvPr/>
          </p:nvSpPr>
          <p:spPr>
            <a:xfrm>
              <a:off x="1163520" y="4008240"/>
              <a:ext cx="3632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9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9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CasellaDiTesto 35"/>
            <p:cNvSpPr/>
            <p:nvPr/>
          </p:nvSpPr>
          <p:spPr>
            <a:xfrm>
              <a:off x="1908000" y="4008240"/>
              <a:ext cx="3603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3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3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CasellaDiTesto 36"/>
            <p:cNvSpPr/>
            <p:nvPr/>
          </p:nvSpPr>
          <p:spPr>
            <a:xfrm>
              <a:off x="2665080" y="4008240"/>
              <a:ext cx="3603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2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1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CasellaDiTesto 37"/>
            <p:cNvSpPr/>
            <p:nvPr/>
          </p:nvSpPr>
          <p:spPr>
            <a:xfrm>
              <a:off x="3419280" y="4008240"/>
              <a:ext cx="3603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1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64" name="AutoShape 26"/>
            <p:cNvCxnSpPr/>
            <p:nvPr/>
          </p:nvCxnSpPr>
          <p:spPr>
            <a:xfrm>
              <a:off x="4631400" y="4107240"/>
              <a:ext cx="386280" cy="360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cxnSp>
          <p:nvCxnSpPr>
            <p:cNvPr id="65" name="AutoShape 27"/>
            <p:cNvCxnSpPr/>
            <p:nvPr/>
          </p:nvCxnSpPr>
          <p:spPr>
            <a:xfrm>
              <a:off x="4631400" y="4237200"/>
              <a:ext cx="384840" cy="3600"/>
            </a:xfrm>
            <a:prstGeom prst="straightConnector1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</p:cxnSp>
        <p:sp>
          <p:nvSpPr>
            <p:cNvPr id="66" name="CasellaDiTesto 32"/>
            <p:cNvSpPr/>
            <p:nvPr/>
          </p:nvSpPr>
          <p:spPr>
            <a:xfrm>
              <a:off x="4568400" y="3861000"/>
              <a:ext cx="504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t ris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CasellaDiTesto 33"/>
            <p:cNvSpPr/>
            <p:nvPr/>
          </p:nvSpPr>
          <p:spPr>
            <a:xfrm>
              <a:off x="4839840" y="4008600"/>
              <a:ext cx="502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21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22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CasellaDiTesto 34"/>
            <p:cNvSpPr/>
            <p:nvPr/>
          </p:nvSpPr>
          <p:spPr>
            <a:xfrm>
              <a:off x="5716080" y="4008600"/>
              <a:ext cx="3632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8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9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CasellaDiTesto 35"/>
            <p:cNvSpPr/>
            <p:nvPr/>
          </p:nvSpPr>
          <p:spPr>
            <a:xfrm>
              <a:off x="6460560" y="4008600"/>
              <a:ext cx="3603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3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3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CasellaDiTesto 36"/>
            <p:cNvSpPr/>
            <p:nvPr/>
          </p:nvSpPr>
          <p:spPr>
            <a:xfrm>
              <a:off x="7218000" y="4008600"/>
              <a:ext cx="3603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1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CasellaDiTesto 37"/>
            <p:cNvSpPr/>
            <p:nvPr/>
          </p:nvSpPr>
          <p:spPr>
            <a:xfrm>
              <a:off x="7924320" y="4008600"/>
              <a:ext cx="3603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Text Box 12"/>
            <p:cNvSpPr/>
            <p:nvPr/>
          </p:nvSpPr>
          <p:spPr>
            <a:xfrm>
              <a:off x="5995800" y="963360"/>
              <a:ext cx="2857320" cy="12031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              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djusted Median, 95% C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-drug regimens (n=212)           10.4, 9.4-12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-drug regimens (n=221)           10.3, 9.2-11.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- </a:t>
              </a:r>
              <a:r>
                <a:rPr b="0" lang="en-GB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versus</a:t>
              </a:r>
              <a:r>
                <a:rPr b="0" i="1" lang="it-IT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-drug containing     Adjusted HR, 95% C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                                                 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.03, 0.85-1.25;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P =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0.78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73" name="AutoShape 26"/>
            <p:cNvCxnSpPr/>
            <p:nvPr/>
          </p:nvCxnSpPr>
          <p:spPr>
            <a:xfrm>
              <a:off x="5614200" y="1180800"/>
              <a:ext cx="410040" cy="360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cxnSp>
          <p:nvCxnSpPr>
            <p:cNvPr id="74" name="AutoShape 27"/>
            <p:cNvCxnSpPr/>
            <p:nvPr/>
          </p:nvCxnSpPr>
          <p:spPr>
            <a:xfrm>
              <a:off x="5623920" y="1323720"/>
              <a:ext cx="408600" cy="3600"/>
            </a:xfrm>
            <a:prstGeom prst="straightConnector1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</p:cxn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5" name="Gruppo 33"/>
          <p:cNvGrpSpPr/>
          <p:nvPr/>
        </p:nvGrpSpPr>
        <p:grpSpPr>
          <a:xfrm>
            <a:off x="15840" y="725400"/>
            <a:ext cx="8962920" cy="3620520"/>
            <a:chOff x="15840" y="725400"/>
            <a:chExt cx="8962920" cy="3620520"/>
          </a:xfrm>
        </p:grpSpPr>
        <p:pic>
          <p:nvPicPr>
            <p:cNvPr id="76" name="Picture 3" descr="I:\backup\Analisi\FAST\2010_03_16\adj_pfs_2_vs_3.gif"/>
            <p:cNvPicPr/>
            <p:nvPr/>
          </p:nvPicPr>
          <p:blipFill>
            <a:blip r:embed="rId1"/>
            <a:stretch/>
          </p:blipFill>
          <p:spPr>
            <a:xfrm>
              <a:off x="4788000" y="827640"/>
              <a:ext cx="4190760" cy="3143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7" name="Picture 2" descr="I:\backup\Analisi\FAST\2010_03_16\adj_pfs_p_vs_n.gif"/>
            <p:cNvPicPr/>
            <p:nvPr/>
          </p:nvPicPr>
          <p:blipFill>
            <a:blip r:embed="rId2"/>
            <a:stretch/>
          </p:blipFill>
          <p:spPr>
            <a:xfrm>
              <a:off x="251640" y="827640"/>
              <a:ext cx="4190760" cy="3143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8" name="CasellaDiTesto 27"/>
            <p:cNvSpPr/>
            <p:nvPr/>
          </p:nvSpPr>
          <p:spPr>
            <a:xfrm>
              <a:off x="131400" y="726840"/>
              <a:ext cx="360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CasellaDiTesto 29"/>
            <p:cNvSpPr/>
            <p:nvPr/>
          </p:nvSpPr>
          <p:spPr>
            <a:xfrm>
              <a:off x="4673520" y="725400"/>
              <a:ext cx="3585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D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80" name="AutoShape 26"/>
            <p:cNvCxnSpPr/>
            <p:nvPr/>
          </p:nvCxnSpPr>
          <p:spPr>
            <a:xfrm>
              <a:off x="1018440" y="1174680"/>
              <a:ext cx="386280" cy="360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cxnSp>
          <p:nvCxnSpPr>
            <p:cNvPr id="81" name="AutoShape 27"/>
            <p:cNvCxnSpPr/>
            <p:nvPr/>
          </p:nvCxnSpPr>
          <p:spPr>
            <a:xfrm>
              <a:off x="1018440" y="1323720"/>
              <a:ext cx="384840" cy="3600"/>
            </a:xfrm>
            <a:prstGeom prst="straightConnector1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</p:cxnSp>
        <p:cxnSp>
          <p:nvCxnSpPr>
            <p:cNvPr id="82" name="AutoShape 26"/>
            <p:cNvCxnSpPr/>
            <p:nvPr/>
          </p:nvCxnSpPr>
          <p:spPr>
            <a:xfrm>
              <a:off x="78840" y="4106880"/>
              <a:ext cx="386280" cy="360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cxnSp>
          <p:nvCxnSpPr>
            <p:cNvPr id="83" name="AutoShape 27"/>
            <p:cNvCxnSpPr/>
            <p:nvPr/>
          </p:nvCxnSpPr>
          <p:spPr>
            <a:xfrm>
              <a:off x="78840" y="4237200"/>
              <a:ext cx="384840" cy="3600"/>
            </a:xfrm>
            <a:prstGeom prst="straightConnector1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</p:cxnSp>
        <p:sp>
          <p:nvSpPr>
            <p:cNvPr id="84" name="CasellaDiTesto 32"/>
            <p:cNvSpPr/>
            <p:nvPr/>
          </p:nvSpPr>
          <p:spPr>
            <a:xfrm>
              <a:off x="15840" y="3860640"/>
              <a:ext cx="504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t ris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CasellaDiTesto 33"/>
            <p:cNvSpPr/>
            <p:nvPr/>
          </p:nvSpPr>
          <p:spPr>
            <a:xfrm>
              <a:off x="287280" y="4008240"/>
              <a:ext cx="502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21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21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CasellaDiTesto 34"/>
            <p:cNvSpPr/>
            <p:nvPr/>
          </p:nvSpPr>
          <p:spPr>
            <a:xfrm>
              <a:off x="1163520" y="4008240"/>
              <a:ext cx="3632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3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3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CasellaDiTesto 35"/>
            <p:cNvSpPr/>
            <p:nvPr/>
          </p:nvSpPr>
          <p:spPr>
            <a:xfrm>
              <a:off x="1908000" y="4008240"/>
              <a:ext cx="3603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1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CasellaDiTesto 36"/>
            <p:cNvSpPr/>
            <p:nvPr/>
          </p:nvSpPr>
          <p:spPr>
            <a:xfrm>
              <a:off x="2665080" y="4008240"/>
              <a:ext cx="3603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CasellaDiTesto 37"/>
            <p:cNvSpPr/>
            <p:nvPr/>
          </p:nvSpPr>
          <p:spPr>
            <a:xfrm>
              <a:off x="3400200" y="4008240"/>
              <a:ext cx="3603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90" name="AutoShape 26"/>
            <p:cNvCxnSpPr/>
            <p:nvPr/>
          </p:nvCxnSpPr>
          <p:spPr>
            <a:xfrm>
              <a:off x="4631400" y="4107240"/>
              <a:ext cx="386280" cy="360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cxnSp>
          <p:nvCxnSpPr>
            <p:cNvPr id="91" name="AutoShape 27"/>
            <p:cNvCxnSpPr/>
            <p:nvPr/>
          </p:nvCxnSpPr>
          <p:spPr>
            <a:xfrm>
              <a:off x="4631400" y="4237200"/>
              <a:ext cx="384840" cy="3600"/>
            </a:xfrm>
            <a:prstGeom prst="straightConnector1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</p:cxnSp>
        <p:sp>
          <p:nvSpPr>
            <p:cNvPr id="92" name="CasellaDiTesto 32"/>
            <p:cNvSpPr/>
            <p:nvPr/>
          </p:nvSpPr>
          <p:spPr>
            <a:xfrm>
              <a:off x="4568400" y="3861000"/>
              <a:ext cx="504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t ris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CasellaDiTesto 33"/>
            <p:cNvSpPr/>
            <p:nvPr/>
          </p:nvSpPr>
          <p:spPr>
            <a:xfrm>
              <a:off x="4839840" y="4008600"/>
              <a:ext cx="502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21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22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CasellaDiTesto 34"/>
            <p:cNvSpPr/>
            <p:nvPr/>
          </p:nvSpPr>
          <p:spPr>
            <a:xfrm>
              <a:off x="5716080" y="4008600"/>
              <a:ext cx="3632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3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3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CasellaDiTesto 35"/>
            <p:cNvSpPr/>
            <p:nvPr/>
          </p:nvSpPr>
          <p:spPr>
            <a:xfrm>
              <a:off x="6460560" y="4008600"/>
              <a:ext cx="3603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1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1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CasellaDiTesto 36"/>
            <p:cNvSpPr/>
            <p:nvPr/>
          </p:nvSpPr>
          <p:spPr>
            <a:xfrm>
              <a:off x="7189200" y="4008600"/>
              <a:ext cx="3603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CasellaDiTesto 37"/>
            <p:cNvSpPr/>
            <p:nvPr/>
          </p:nvSpPr>
          <p:spPr>
            <a:xfrm>
              <a:off x="7924320" y="4008600"/>
              <a:ext cx="3603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Text Box 15"/>
            <p:cNvSpPr/>
            <p:nvPr/>
          </p:nvSpPr>
          <p:spPr>
            <a:xfrm>
              <a:off x="1371240" y="970920"/>
              <a:ext cx="2971800" cy="10746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                                                   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djusted Median, 95% C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-containing regimens (n=216)            6.4; 5.3-7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N-containing regimens (n=217)            4.9; 4.4-5.8           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N- </a:t>
              </a:r>
              <a:r>
                <a:rPr b="0" lang="en-GB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versus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P-containing                 Adjusted HR, 95% C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                                                     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.26, 1.04-1.53;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P =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0.0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Text Box 16"/>
            <p:cNvSpPr/>
            <p:nvPr/>
          </p:nvSpPr>
          <p:spPr>
            <a:xfrm>
              <a:off x="5945400" y="975240"/>
              <a:ext cx="2950920" cy="12031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                                            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djusted Median, 95% C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-drug regimens (n=212)           5.6, 4.7-6.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-drug regimens (n=221)           5.7, 4.8-6.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- </a:t>
              </a:r>
              <a:r>
                <a:rPr b="0" lang="en-GB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versus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2-drug containing   Adjusted HR; 95% C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                 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.98, 0.81-1.19;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P =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0.8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00" name="AutoShape 26"/>
            <p:cNvCxnSpPr/>
            <p:nvPr/>
          </p:nvCxnSpPr>
          <p:spPr>
            <a:xfrm>
              <a:off x="5563440" y="1178640"/>
              <a:ext cx="386280" cy="360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cxnSp>
          <p:nvCxnSpPr>
            <p:cNvPr id="101" name="AutoShape 27"/>
            <p:cNvCxnSpPr/>
            <p:nvPr/>
          </p:nvCxnSpPr>
          <p:spPr>
            <a:xfrm>
              <a:off x="5563440" y="1327680"/>
              <a:ext cx="384840" cy="3600"/>
            </a:xfrm>
            <a:prstGeom prst="straightConnector1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</p:cxn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30T14:42:14Z</dcterms:created>
  <dc:creator>samsung</dc:creator>
  <dc:description/>
  <dc:language>en-US</dc:language>
  <cp:lastModifiedBy>administrator</cp:lastModifiedBy>
  <dcterms:modified xsi:type="dcterms:W3CDTF">2011-12-09T16:12:44Z</dcterms:modified>
  <cp:revision>35</cp:revision>
  <dc:subject/>
  <dc:title>Diapositiva 1</dc:title>
</cp:coreProperties>
</file>